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48" autoAdjust="0"/>
    <p:restoredTop sz="94674"/>
  </p:normalViewPr>
  <p:slideViewPr>
    <p:cSldViewPr>
      <p:cViewPr>
        <p:scale>
          <a:sx n="163" d="100"/>
          <a:sy n="163" d="100"/>
        </p:scale>
        <p:origin x="864" y="-38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__sunchung__\__Project_MT_2017\IT_SW\CBF_CRISPER_PROJECT\SW4-4_11-7_11-19_project\qPCR\sw-CBFox_011717\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__sunchung__\__Project_MT_2017\IT_SW\CBF_CRISPER_PROJECT\SW4-4_11-7_11-19_project\qPCR\sw-CBFox_011717\summary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__sunchung__\__Project_MT_2017\IT_SW\CBF_CRISPER_PROJECT\SW4-4_11-7_11-19_project\qPCR\sw-CBFox_011717\summar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__sunchung__\__Project_MT_2017\IT_SW\CBF_CRISPER_PROJECT\SW4-4_11-7_11-19_project\qPCR\sw-CBFox_011717\summary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__sunchung__\__Project_MT_2017\IT_SW\CBF_CRISPER_PROJECT\SW4-4_11-7_11-19_project\qPCR\sw-CBFox_011717\summary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__sunchung__\__Project_MT_2017\IT_SW\CBF_CRISPER_PROJECT\SW4-4_11-7_11-19_project\qPCR\sw-CBFox_011717\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CBF1_CBF2!$B$1</c:f>
          <c:strCache>
            <c:ptCount val="1"/>
            <c:pt idx="0">
              <c:v>CBF1</c:v>
            </c:pt>
          </c:strCache>
        </c:strRef>
      </c:tx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469486016234726"/>
          <c:y val="0.14278158557115755"/>
          <c:w val="0.85331282265213537"/>
          <c:h val="0.75930720315563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BF1_CBF2!$B$1</c:f>
              <c:strCache>
                <c:ptCount val="1"/>
                <c:pt idx="0">
                  <c:v>CBF1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CBF1_CBF2!$C$2:$C$8</c:f>
                <c:numCache>
                  <c:formatCode>General</c:formatCode>
                  <c:ptCount val="7"/>
                  <c:pt idx="0">
                    <c:v>0.38852860512630716</c:v>
                  </c:pt>
                  <c:pt idx="1">
                    <c:v>0.23287300024114632</c:v>
                  </c:pt>
                  <c:pt idx="2">
                    <c:v>0.21308238408499836</c:v>
                  </c:pt>
                  <c:pt idx="3">
                    <c:v>0.23149400941924123</c:v>
                  </c:pt>
                  <c:pt idx="4">
                    <c:v>0.27517079261554922</c:v>
                  </c:pt>
                  <c:pt idx="5">
                    <c:v>0.31760308647348956</c:v>
                  </c:pt>
                  <c:pt idx="6">
                    <c:v>0.1096397064339974</c:v>
                  </c:pt>
                </c:numCache>
              </c:numRef>
            </c:plus>
            <c:minus>
              <c:numRef>
                <c:f>CBF1_CBF2!$C$2:$C$8</c:f>
                <c:numCache>
                  <c:formatCode>General</c:formatCode>
                  <c:ptCount val="7"/>
                  <c:pt idx="0">
                    <c:v>0.38852860512630716</c:v>
                  </c:pt>
                  <c:pt idx="1">
                    <c:v>0.23287300024114632</c:v>
                  </c:pt>
                  <c:pt idx="2">
                    <c:v>0.21308238408499836</c:v>
                  </c:pt>
                  <c:pt idx="3">
                    <c:v>0.23149400941924123</c:v>
                  </c:pt>
                  <c:pt idx="4">
                    <c:v>0.27517079261554922</c:v>
                  </c:pt>
                  <c:pt idx="5">
                    <c:v>0.31760308647348956</c:v>
                  </c:pt>
                  <c:pt idx="6">
                    <c:v>0.1096397064339974</c:v>
                  </c:pt>
                </c:numCache>
              </c:numRef>
            </c:minus>
          </c:errBars>
          <c:cat>
            <c:strRef>
              <c:f>CBF1_CBF2!$A$2:$A$6</c:f>
              <c:strCache>
                <c:ptCount val="5"/>
                <c:pt idx="0">
                  <c:v>Ws2</c:v>
                </c:pt>
                <c:pt idx="1">
                  <c:v>SW:CBF2ox</c:v>
                </c:pt>
                <c:pt idx="2">
                  <c:v>SW:CBF2ox</c:v>
                </c:pt>
                <c:pt idx="3">
                  <c:v>cbf2ox</c:v>
                </c:pt>
                <c:pt idx="4">
                  <c:v>cbf2ox</c:v>
                </c:pt>
              </c:strCache>
            </c:strRef>
          </c:cat>
          <c:val>
            <c:numRef>
              <c:f>CBF1_CBF2!$B$2:$B$6</c:f>
              <c:numCache>
                <c:formatCode>General</c:formatCode>
                <c:ptCount val="5"/>
                <c:pt idx="0">
                  <c:v>1.1191685759085002</c:v>
                </c:pt>
                <c:pt idx="1">
                  <c:v>1.4022625218143672</c:v>
                </c:pt>
                <c:pt idx="2">
                  <c:v>1.7691243887010761</c:v>
                </c:pt>
                <c:pt idx="3">
                  <c:v>1.613797781818312</c:v>
                </c:pt>
                <c:pt idx="4">
                  <c:v>1.76448959055747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50-FD40-96B7-6987264A44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8049536"/>
        <c:axId val="88051072"/>
      </c:barChart>
      <c:catAx>
        <c:axId val="880495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88051072"/>
        <c:crosses val="autoZero"/>
        <c:auto val="1"/>
        <c:lblAlgn val="ctr"/>
        <c:lblOffset val="100"/>
        <c:noMultiLvlLbl val="0"/>
      </c:catAx>
      <c:valAx>
        <c:axId val="88051072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crossAx val="88049536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CBF1_CBF2!$B$12</c:f>
          <c:strCache>
            <c:ptCount val="1"/>
            <c:pt idx="0">
              <c:v>CBF2</c:v>
            </c:pt>
          </c:strCache>
        </c:strRef>
      </c:tx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821368876400752"/>
          <c:y val="0.14278158557115755"/>
          <c:w val="0.84178631123599246"/>
          <c:h val="0.75930720315563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BF1_CBF2!$B$1</c:f>
              <c:strCache>
                <c:ptCount val="1"/>
                <c:pt idx="0">
                  <c:v>CBF1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CBF1_CBF2!$C$13:$C$19</c:f>
                <c:numCache>
                  <c:formatCode>General</c:formatCode>
                  <c:ptCount val="7"/>
                  <c:pt idx="0">
                    <c:v>5.7774180650122318E-2</c:v>
                  </c:pt>
                  <c:pt idx="1">
                    <c:v>22.538011735837554</c:v>
                  </c:pt>
                  <c:pt idx="2">
                    <c:v>44.968171566215133</c:v>
                  </c:pt>
                  <c:pt idx="3">
                    <c:v>9.4449345534616409</c:v>
                  </c:pt>
                  <c:pt idx="4">
                    <c:v>15.009456077046215</c:v>
                  </c:pt>
                  <c:pt idx="5">
                    <c:v>32.321999329257032</c:v>
                  </c:pt>
                  <c:pt idx="6">
                    <c:v>37.237365740462138</c:v>
                  </c:pt>
                </c:numCache>
              </c:numRef>
            </c:plus>
            <c:minus>
              <c:numRef>
                <c:f>CBF1_CBF2!$C$13:$C$19</c:f>
                <c:numCache>
                  <c:formatCode>General</c:formatCode>
                  <c:ptCount val="7"/>
                  <c:pt idx="0">
                    <c:v>5.7774180650122318E-2</c:v>
                  </c:pt>
                  <c:pt idx="1">
                    <c:v>22.538011735837554</c:v>
                  </c:pt>
                  <c:pt idx="2">
                    <c:v>44.968171566215133</c:v>
                  </c:pt>
                  <c:pt idx="3">
                    <c:v>9.4449345534616409</c:v>
                  </c:pt>
                  <c:pt idx="4">
                    <c:v>15.009456077046215</c:v>
                  </c:pt>
                  <c:pt idx="5">
                    <c:v>32.321999329257032</c:v>
                  </c:pt>
                  <c:pt idx="6">
                    <c:v>37.237365740462138</c:v>
                  </c:pt>
                </c:numCache>
              </c:numRef>
            </c:minus>
          </c:errBars>
          <c:cat>
            <c:strRef>
              <c:f>CBF1_CBF2!$A$13:$A$17</c:f>
              <c:strCache>
                <c:ptCount val="5"/>
                <c:pt idx="0">
                  <c:v>Ws2</c:v>
                </c:pt>
                <c:pt idx="1">
                  <c:v>SW-CBF2ox</c:v>
                </c:pt>
                <c:pt idx="2">
                  <c:v>SW-CBF2ox</c:v>
                </c:pt>
                <c:pt idx="3">
                  <c:v>sw51-cbf2ox</c:v>
                </c:pt>
                <c:pt idx="4">
                  <c:v>sw51-cbf2ox</c:v>
                </c:pt>
              </c:strCache>
            </c:strRef>
          </c:cat>
          <c:val>
            <c:numRef>
              <c:f>CBF1_CBF2!$B$13:$B$17</c:f>
              <c:numCache>
                <c:formatCode>General</c:formatCode>
                <c:ptCount val="5"/>
                <c:pt idx="0">
                  <c:v>1.0032130082000457</c:v>
                </c:pt>
                <c:pt idx="1">
                  <c:v>149.48272900305452</c:v>
                </c:pt>
                <c:pt idx="2">
                  <c:v>191.96288018476866</c:v>
                </c:pt>
                <c:pt idx="3">
                  <c:v>190.48677312611085</c:v>
                </c:pt>
                <c:pt idx="4">
                  <c:v>438.138539634146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64-3B49-8F96-2FA7D5E139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962688"/>
        <c:axId val="36964224"/>
      </c:barChart>
      <c:catAx>
        <c:axId val="36962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6964224"/>
        <c:crosses val="autoZero"/>
        <c:auto val="1"/>
        <c:lblAlgn val="ctr"/>
        <c:lblOffset val="100"/>
        <c:noMultiLvlLbl val="0"/>
      </c:catAx>
      <c:valAx>
        <c:axId val="36964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6962688"/>
        <c:crosses val="autoZero"/>
        <c:crossBetween val="between"/>
        <c:majorUnit val="100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F3_Gols3!$B$1</c:f>
          <c:strCache>
            <c:ptCount val="1"/>
            <c:pt idx="0">
              <c:v>CBF3</c:v>
            </c:pt>
          </c:strCache>
        </c:strRef>
      </c:tx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8639098158230507E-2"/>
          <c:y val="0.14278158557115755"/>
          <c:w val="0.8557511461967543"/>
          <c:h val="0.75930720315563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3_Gols3!$B$1</c:f>
              <c:strCache>
                <c:ptCount val="1"/>
                <c:pt idx="0">
                  <c:v>CBF3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F3_Gols3!$C$2:$C$8</c:f>
                <c:numCache>
                  <c:formatCode>General</c:formatCode>
                  <c:ptCount val="7"/>
                  <c:pt idx="0">
                    <c:v>0.18860783424749203</c:v>
                  </c:pt>
                  <c:pt idx="1">
                    <c:v>0.34806044797555502</c:v>
                  </c:pt>
                  <c:pt idx="2">
                    <c:v>0.58838354834462447</c:v>
                  </c:pt>
                  <c:pt idx="3">
                    <c:v>3.0608162465509299E-2</c:v>
                  </c:pt>
                  <c:pt idx="4">
                    <c:v>9.7092389003116314E-2</c:v>
                  </c:pt>
                  <c:pt idx="5">
                    <c:v>0.19566851129289359</c:v>
                  </c:pt>
                  <c:pt idx="6">
                    <c:v>4.1038086498485483E-2</c:v>
                  </c:pt>
                </c:numCache>
              </c:numRef>
            </c:plus>
            <c:minus>
              <c:numRef>
                <c:f>F3_Gols3!$C$2:$C$8</c:f>
                <c:numCache>
                  <c:formatCode>General</c:formatCode>
                  <c:ptCount val="7"/>
                  <c:pt idx="0">
                    <c:v>0.18860783424749203</c:v>
                  </c:pt>
                  <c:pt idx="1">
                    <c:v>0.34806044797555502</c:v>
                  </c:pt>
                  <c:pt idx="2">
                    <c:v>0.58838354834462447</c:v>
                  </c:pt>
                  <c:pt idx="3">
                    <c:v>3.0608162465509299E-2</c:v>
                  </c:pt>
                  <c:pt idx="4">
                    <c:v>9.7092389003116314E-2</c:v>
                  </c:pt>
                  <c:pt idx="5">
                    <c:v>0.19566851129289359</c:v>
                  </c:pt>
                  <c:pt idx="6">
                    <c:v>4.1038086498485483E-2</c:v>
                  </c:pt>
                </c:numCache>
              </c:numRef>
            </c:minus>
          </c:errBars>
          <c:cat>
            <c:strRef>
              <c:f>F3_Gols3!$A$2:$A$6</c:f>
              <c:strCache>
                <c:ptCount val="5"/>
                <c:pt idx="0">
                  <c:v>Ws2</c:v>
                </c:pt>
                <c:pt idx="1">
                  <c:v>SW-CBF2ox</c:v>
                </c:pt>
                <c:pt idx="2">
                  <c:v>SW-CBF2ox</c:v>
                </c:pt>
                <c:pt idx="3">
                  <c:v>sw51-cbf2ox</c:v>
                </c:pt>
                <c:pt idx="4">
                  <c:v>sw51-cbf2ox</c:v>
                </c:pt>
              </c:strCache>
            </c:strRef>
          </c:cat>
          <c:val>
            <c:numRef>
              <c:f>F3_Gols3!$B$2:$B$6</c:f>
              <c:numCache>
                <c:formatCode>General</c:formatCode>
                <c:ptCount val="5"/>
                <c:pt idx="0">
                  <c:v>1.0371235739410105</c:v>
                </c:pt>
                <c:pt idx="1">
                  <c:v>2.356069128435887</c:v>
                </c:pt>
                <c:pt idx="2">
                  <c:v>2.404189856125269</c:v>
                </c:pt>
                <c:pt idx="3">
                  <c:v>1.5889552009235306</c:v>
                </c:pt>
                <c:pt idx="4">
                  <c:v>1.37874311537022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62-7D4E-A9FE-0722A5D2E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980992"/>
        <c:axId val="36982784"/>
      </c:barChart>
      <c:catAx>
        <c:axId val="369809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6982784"/>
        <c:crosses val="autoZero"/>
        <c:auto val="1"/>
        <c:lblAlgn val="ctr"/>
        <c:lblOffset val="100"/>
        <c:noMultiLvlLbl val="0"/>
      </c:catAx>
      <c:valAx>
        <c:axId val="36982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69809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F3_Gols3!$B$12</c:f>
          <c:strCache>
            <c:ptCount val="1"/>
            <c:pt idx="0">
              <c:v>Gols3</c:v>
            </c:pt>
          </c:strCache>
        </c:strRef>
      </c:tx>
      <c:layout>
        <c:manualLayout>
          <c:xMode val="edge"/>
          <c:yMode val="edge"/>
          <c:x val="0.39252191222784694"/>
          <c:y val="8.9285714285714288E-2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874179664524462"/>
          <c:y val="0.14278158557115755"/>
          <c:w val="0.84789645914418543"/>
          <c:h val="0.75930720315563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3_Gols3!$B$1</c:f>
              <c:strCache>
                <c:ptCount val="1"/>
                <c:pt idx="0">
                  <c:v>CBF3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F3_Gols3!$C$13:$C$19</c:f>
                <c:numCache>
                  <c:formatCode>General</c:formatCode>
                  <c:ptCount val="7"/>
                  <c:pt idx="0">
                    <c:v>0.13224810644603172</c:v>
                  </c:pt>
                  <c:pt idx="1">
                    <c:v>26.130109820106721</c:v>
                  </c:pt>
                  <c:pt idx="2">
                    <c:v>30.743241851020318</c:v>
                  </c:pt>
                  <c:pt idx="3">
                    <c:v>0.12348213189578219</c:v>
                  </c:pt>
                  <c:pt idx="4">
                    <c:v>0.11659902557137908</c:v>
                  </c:pt>
                  <c:pt idx="5">
                    <c:v>0.28039208324454967</c:v>
                  </c:pt>
                  <c:pt idx="6">
                    <c:v>8.2625134059398184E-2</c:v>
                  </c:pt>
                </c:numCache>
              </c:numRef>
            </c:plus>
            <c:minus>
              <c:numRef>
                <c:f>F3_Gols3!$C$13:$C$19</c:f>
                <c:numCache>
                  <c:formatCode>General</c:formatCode>
                  <c:ptCount val="7"/>
                  <c:pt idx="0">
                    <c:v>0.13224810644603172</c:v>
                  </c:pt>
                  <c:pt idx="1">
                    <c:v>26.130109820106721</c:v>
                  </c:pt>
                  <c:pt idx="2">
                    <c:v>30.743241851020318</c:v>
                  </c:pt>
                  <c:pt idx="3">
                    <c:v>0.12348213189578219</c:v>
                  </c:pt>
                  <c:pt idx="4">
                    <c:v>0.11659902557137908</c:v>
                  </c:pt>
                  <c:pt idx="5">
                    <c:v>0.28039208324454967</c:v>
                  </c:pt>
                  <c:pt idx="6">
                    <c:v>8.2625134059398184E-2</c:v>
                  </c:pt>
                </c:numCache>
              </c:numRef>
            </c:minus>
          </c:errBars>
          <c:cat>
            <c:strRef>
              <c:f>F3_Gols3!$A$13:$A$17</c:f>
              <c:strCache>
                <c:ptCount val="5"/>
                <c:pt idx="0">
                  <c:v>Ws2</c:v>
                </c:pt>
                <c:pt idx="1">
                  <c:v>SW-CBF2ox</c:v>
                </c:pt>
                <c:pt idx="2">
                  <c:v>SW-CBF2ox</c:v>
                </c:pt>
                <c:pt idx="3">
                  <c:v>sw51-cbf2ox</c:v>
                </c:pt>
                <c:pt idx="4">
                  <c:v>sw51-cbf2ox</c:v>
                </c:pt>
              </c:strCache>
            </c:strRef>
          </c:cat>
          <c:val>
            <c:numRef>
              <c:f>F3_Gols3!$B$13:$B$17</c:f>
              <c:numCache>
                <c:formatCode>General</c:formatCode>
                <c:ptCount val="5"/>
                <c:pt idx="0">
                  <c:v>1.0186053141540079</c:v>
                </c:pt>
                <c:pt idx="1">
                  <c:v>170.92922705531126</c:v>
                </c:pt>
                <c:pt idx="2">
                  <c:v>181.35139046418314</c:v>
                </c:pt>
                <c:pt idx="3">
                  <c:v>2.3180077369018641</c:v>
                </c:pt>
                <c:pt idx="4">
                  <c:v>2.06599356530708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44-9446-98DF-EEB69CBDB1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995456"/>
        <c:axId val="36996992"/>
      </c:barChart>
      <c:catAx>
        <c:axId val="369954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6996992"/>
        <c:crosses val="autoZero"/>
        <c:auto val="1"/>
        <c:lblAlgn val="ctr"/>
        <c:lblOffset val="100"/>
        <c:noMultiLvlLbl val="0"/>
      </c:catAx>
      <c:valAx>
        <c:axId val="36996992"/>
        <c:scaling>
          <c:orientation val="minMax"/>
          <c:max val="300"/>
        </c:scaling>
        <c:delete val="0"/>
        <c:axPos val="l"/>
        <c:numFmt formatCode="General" sourceLinked="1"/>
        <c:majorTickMark val="out"/>
        <c:minorTickMark val="none"/>
        <c:tickLblPos val="nextTo"/>
        <c:crossAx val="36995456"/>
        <c:crosses val="autoZero"/>
        <c:crossBetween val="between"/>
        <c:majorUnit val="100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COR15a COR47'!$B$1</c:f>
          <c:strCache>
            <c:ptCount val="1"/>
            <c:pt idx="0">
              <c:v>COR15</c:v>
            </c:pt>
          </c:strCache>
        </c:strRef>
      </c:tx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695976606639129"/>
          <c:y val="0.14278158557115755"/>
          <c:w val="0.85967848972303884"/>
          <c:h val="0.75930720315563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R15a COR47'!$B$1</c:f>
              <c:strCache>
                <c:ptCount val="1"/>
                <c:pt idx="0">
                  <c:v>COR1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OR15a COR47'!$C$2:$C$8</c:f>
                <c:numCache>
                  <c:formatCode>General</c:formatCode>
                  <c:ptCount val="7"/>
                  <c:pt idx="0">
                    <c:v>0.3314073094736209</c:v>
                  </c:pt>
                  <c:pt idx="1">
                    <c:v>64.900736980383229</c:v>
                  </c:pt>
                  <c:pt idx="2">
                    <c:v>51.43087497389682</c:v>
                  </c:pt>
                  <c:pt idx="3">
                    <c:v>0.49508477844756288</c:v>
                  </c:pt>
                  <c:pt idx="4">
                    <c:v>0.21263789130818569</c:v>
                  </c:pt>
                  <c:pt idx="5">
                    <c:v>0.39889114701170242</c:v>
                  </c:pt>
                  <c:pt idx="6">
                    <c:v>7.7462368021709499E-2</c:v>
                  </c:pt>
                </c:numCache>
              </c:numRef>
            </c:plus>
            <c:minus>
              <c:numRef>
                <c:f>'COR15a COR47'!$C$2:$C$8</c:f>
                <c:numCache>
                  <c:formatCode>General</c:formatCode>
                  <c:ptCount val="7"/>
                  <c:pt idx="0">
                    <c:v>0.3314073094736209</c:v>
                  </c:pt>
                  <c:pt idx="1">
                    <c:v>64.900736980383229</c:v>
                  </c:pt>
                  <c:pt idx="2">
                    <c:v>51.43087497389682</c:v>
                  </c:pt>
                  <c:pt idx="3">
                    <c:v>0.49508477844756288</c:v>
                  </c:pt>
                  <c:pt idx="4">
                    <c:v>0.21263789130818569</c:v>
                  </c:pt>
                  <c:pt idx="5">
                    <c:v>0.39889114701170242</c:v>
                  </c:pt>
                  <c:pt idx="6">
                    <c:v>7.7462368021709499E-2</c:v>
                  </c:pt>
                </c:numCache>
              </c:numRef>
            </c:minus>
          </c:errBars>
          <c:cat>
            <c:strRef>
              <c:f>'COR15a COR47'!$A$2:$A$6</c:f>
              <c:strCache>
                <c:ptCount val="5"/>
                <c:pt idx="0">
                  <c:v>Ws2</c:v>
                </c:pt>
                <c:pt idx="1">
                  <c:v>SW-CBF2ox</c:v>
                </c:pt>
                <c:pt idx="2">
                  <c:v>SW-CBF2ox</c:v>
                </c:pt>
                <c:pt idx="3">
                  <c:v>sw51-cbf2ox</c:v>
                </c:pt>
                <c:pt idx="4">
                  <c:v>sw51-cbf2ox</c:v>
                </c:pt>
              </c:strCache>
            </c:strRef>
          </c:cat>
          <c:val>
            <c:numRef>
              <c:f>'COR15a COR47'!$B$2:$B$6</c:f>
              <c:numCache>
                <c:formatCode>General</c:formatCode>
                <c:ptCount val="5"/>
                <c:pt idx="0">
                  <c:v>1.1096614294272393</c:v>
                </c:pt>
                <c:pt idx="1">
                  <c:v>356.11779935473032</c:v>
                </c:pt>
                <c:pt idx="2">
                  <c:v>339.88689714632886</c:v>
                </c:pt>
                <c:pt idx="3">
                  <c:v>5.9347968232233663</c:v>
                </c:pt>
                <c:pt idx="4">
                  <c:v>4.57179987711873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26-EE4A-BA60-5A7DF38CA3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026048"/>
        <c:axId val="40124416"/>
      </c:barChart>
      <c:catAx>
        <c:axId val="37026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40124416"/>
        <c:crosses val="autoZero"/>
        <c:auto val="1"/>
        <c:lblAlgn val="ctr"/>
        <c:lblOffset val="100"/>
        <c:noMultiLvlLbl val="0"/>
      </c:catAx>
      <c:valAx>
        <c:axId val="401244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7026048"/>
        <c:crosses val="autoZero"/>
        <c:crossBetween val="between"/>
        <c:majorUnit val="100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COR15a COR47'!$B$12</c:f>
          <c:strCache>
            <c:ptCount val="1"/>
            <c:pt idx="0">
              <c:v>COR47</c:v>
            </c:pt>
          </c:strCache>
        </c:strRef>
      </c:tx>
      <c:overlay val="0"/>
      <c:txPr>
        <a:bodyPr/>
        <a:lstStyle/>
        <a:p>
          <a:pPr>
            <a:defRPr i="1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308151742658187"/>
          <c:y val="0.14278158557115755"/>
          <c:w val="0.85967848972303884"/>
          <c:h val="0.759307203155634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OR15a COR47'!$B$1</c:f>
              <c:strCache>
                <c:ptCount val="1"/>
                <c:pt idx="0">
                  <c:v>COR15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COR15a COR47'!$C$13:$C$19</c:f>
                <c:numCache>
                  <c:formatCode>General</c:formatCode>
                  <c:ptCount val="7"/>
                  <c:pt idx="0">
                    <c:v>5.691851104872582E-2</c:v>
                  </c:pt>
                  <c:pt idx="1">
                    <c:v>0.85626157835373329</c:v>
                  </c:pt>
                  <c:pt idx="2">
                    <c:v>1.8783203535793114</c:v>
                  </c:pt>
                  <c:pt idx="3">
                    <c:v>9.0122740481292082E-2</c:v>
                  </c:pt>
                  <c:pt idx="4">
                    <c:v>0.10841101514071184</c:v>
                  </c:pt>
                  <c:pt idx="5">
                    <c:v>6.812942480569964E-2</c:v>
                  </c:pt>
                  <c:pt idx="6">
                    <c:v>6.8553957571983876E-2</c:v>
                  </c:pt>
                </c:numCache>
              </c:numRef>
            </c:plus>
            <c:minus>
              <c:numRef>
                <c:f>'COR15a COR47'!$C$13:$C$19</c:f>
                <c:numCache>
                  <c:formatCode>General</c:formatCode>
                  <c:ptCount val="7"/>
                  <c:pt idx="0">
                    <c:v>5.691851104872582E-2</c:v>
                  </c:pt>
                  <c:pt idx="1">
                    <c:v>0.85626157835373329</c:v>
                  </c:pt>
                  <c:pt idx="2">
                    <c:v>1.8783203535793114</c:v>
                  </c:pt>
                  <c:pt idx="3">
                    <c:v>9.0122740481292082E-2</c:v>
                  </c:pt>
                  <c:pt idx="4">
                    <c:v>0.10841101514071184</c:v>
                  </c:pt>
                  <c:pt idx="5">
                    <c:v>6.812942480569964E-2</c:v>
                  </c:pt>
                  <c:pt idx="6">
                    <c:v>6.8553957571983876E-2</c:v>
                  </c:pt>
                </c:numCache>
              </c:numRef>
            </c:minus>
          </c:errBars>
          <c:cat>
            <c:strRef>
              <c:f>'COR15a COR47'!$A$13:$A$17</c:f>
              <c:strCache>
                <c:ptCount val="5"/>
                <c:pt idx="0">
                  <c:v>Ws2</c:v>
                </c:pt>
                <c:pt idx="1">
                  <c:v>SW-CBF2ox</c:v>
                </c:pt>
                <c:pt idx="2">
                  <c:v>SW-CBF2ox</c:v>
                </c:pt>
                <c:pt idx="3">
                  <c:v>sw51-cbf2ox</c:v>
                </c:pt>
                <c:pt idx="4">
                  <c:v>sw51-cbf2ox</c:v>
                </c:pt>
              </c:strCache>
            </c:strRef>
          </c:cat>
          <c:val>
            <c:numRef>
              <c:f>'COR15a COR47'!$B$13:$B$17</c:f>
              <c:numCache>
                <c:formatCode>General</c:formatCode>
                <c:ptCount val="5"/>
                <c:pt idx="0">
                  <c:v>1.0033327317133616</c:v>
                </c:pt>
                <c:pt idx="1">
                  <c:v>10.419054983295219</c:v>
                </c:pt>
                <c:pt idx="2">
                  <c:v>12.586640691347869</c:v>
                </c:pt>
                <c:pt idx="3">
                  <c:v>1.4054732523207243</c:v>
                </c:pt>
                <c:pt idx="4">
                  <c:v>1.03647476517316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92-7B49-84D7-67167922E5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141184"/>
        <c:axId val="40142720"/>
      </c:barChart>
      <c:catAx>
        <c:axId val="401411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40142720"/>
        <c:crosses val="autoZero"/>
        <c:auto val="1"/>
        <c:lblAlgn val="ctr"/>
        <c:lblOffset val="100"/>
        <c:noMultiLvlLbl val="0"/>
      </c:catAx>
      <c:valAx>
        <c:axId val="401427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01411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30E226-D7DD-4781-A018-168D61DA236F}" type="datetimeFigureOut">
              <a:rPr lang="en-US" smtClean="0"/>
              <a:t>11/9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8B2109-89AE-4D74-A9A0-6138A32777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0219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1143000" y="7239907"/>
            <a:ext cx="501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Ws-2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403075" y="7239907"/>
            <a:ext cx="7559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BF2ox</a:t>
            </a:r>
          </a:p>
          <a:p>
            <a:pPr algn="ctr"/>
            <a:r>
              <a:rPr lang="en-US" sz="1200" dirty="0"/>
              <a:t>(sw:</a:t>
            </a:r>
            <a:r>
              <a:rPr lang="en-US" sz="1200" i="1" dirty="0"/>
              <a:t>cbf2</a:t>
            </a:r>
            <a:r>
              <a:rPr lang="en-US" sz="1200" dirty="0"/>
              <a:t>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600200" y="7239907"/>
            <a:ext cx="6399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BF2ox</a:t>
            </a:r>
          </a:p>
          <a:p>
            <a:pPr algn="ctr"/>
            <a:r>
              <a:rPr lang="en-US" sz="1200" dirty="0"/>
              <a:t>(SW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810000" y="7239907"/>
            <a:ext cx="501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Ws-2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056652" y="7239907"/>
            <a:ext cx="75770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BF2ox</a:t>
            </a:r>
          </a:p>
          <a:p>
            <a:pPr algn="ctr"/>
            <a:r>
              <a:rPr lang="en-US" sz="1200" dirty="0"/>
              <a:t>(sw:</a:t>
            </a:r>
            <a:r>
              <a:rPr lang="en-US" sz="1200" i="1" dirty="0"/>
              <a:t>cbf2</a:t>
            </a:r>
            <a:r>
              <a:rPr lang="en-US" sz="1200" dirty="0"/>
              <a:t>)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4409857" y="7239907"/>
            <a:ext cx="6449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BF2ox</a:t>
            </a:r>
          </a:p>
          <a:p>
            <a:pPr algn="ctr"/>
            <a:r>
              <a:rPr lang="en-US" sz="1200" dirty="0"/>
              <a:t>(SW)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1722150" y="4541035"/>
            <a:ext cx="1262499" cy="0"/>
            <a:chOff x="1709778" y="4216400"/>
            <a:chExt cx="1262499" cy="0"/>
          </a:xfrm>
        </p:grpSpPr>
        <p:cxnSp>
          <p:nvCxnSpPr>
            <p:cNvPr id="54" name="Straight Connector 53"/>
            <p:cNvCxnSpPr/>
            <p:nvPr/>
          </p:nvCxnSpPr>
          <p:spPr>
            <a:xfrm>
              <a:off x="1709778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2438474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9" name="TextBox 68"/>
          <p:cNvSpPr txBox="1"/>
          <p:nvPr/>
        </p:nvSpPr>
        <p:spPr>
          <a:xfrm rot="16200000">
            <a:off x="-88900" y="5430798"/>
            <a:ext cx="13849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elative expression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27315" y="7646095"/>
            <a:ext cx="626878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3 Fig. The </a:t>
            </a:r>
            <a:r>
              <a:rPr lang="en-US" sz="1100" b="1" i="1" dirty="0"/>
              <a:t>cbf2</a:t>
            </a:r>
            <a:r>
              <a:rPr lang="en-US" sz="1100" b="1" dirty="0"/>
              <a:t> allele from sw:</a:t>
            </a:r>
            <a:r>
              <a:rPr lang="en-US" sz="1100" b="1" i="1" dirty="0"/>
              <a:t>cbf2</a:t>
            </a:r>
            <a:r>
              <a:rPr lang="en-US" sz="1100" b="1" dirty="0"/>
              <a:t> plants encodes a non-functional protein</a:t>
            </a:r>
            <a:r>
              <a:rPr lang="en-US" sz="1100" dirty="0"/>
              <a:t>.  The </a:t>
            </a:r>
            <a:r>
              <a:rPr lang="en-US" sz="1100" i="1" dirty="0"/>
              <a:t>cbf2 </a:t>
            </a:r>
            <a:r>
              <a:rPr lang="en-US" sz="1100" dirty="0"/>
              <a:t>allele and corresponding </a:t>
            </a:r>
            <a:r>
              <a:rPr lang="en-US" sz="1100" i="1" dirty="0"/>
              <a:t>CBF2</a:t>
            </a:r>
            <a:r>
              <a:rPr lang="en-US" sz="1100" dirty="0"/>
              <a:t> coding sequence from the SW ecotype were overexpressed in Ws-2 plants to determine whether they could induce expression of CBF regulon genes.  (A) Photographs show that overexpression of the </a:t>
            </a:r>
            <a:r>
              <a:rPr lang="en-US" sz="1100" i="1" dirty="0"/>
              <a:t>cbf2</a:t>
            </a:r>
            <a:r>
              <a:rPr lang="en-US" sz="1100" dirty="0"/>
              <a:t> allele did not retard plant growth consistent with the protein being non-functional.  (B) Overexpression of </a:t>
            </a:r>
            <a:r>
              <a:rPr lang="en-US" sz="1100" i="1" dirty="0"/>
              <a:t>cbf2 </a:t>
            </a:r>
            <a:r>
              <a:rPr lang="en-US" sz="1100" dirty="0"/>
              <a:t>did not induce expression of the CBF regulon genes</a:t>
            </a:r>
            <a:r>
              <a:rPr lang="en-US" sz="1100" i="1" dirty="0"/>
              <a:t> Gols3</a:t>
            </a:r>
            <a:r>
              <a:rPr lang="en-US" sz="1100" dirty="0"/>
              <a:t>, </a:t>
            </a:r>
            <a:r>
              <a:rPr lang="en-US" sz="1100" i="1" dirty="0"/>
              <a:t>COR15a</a:t>
            </a:r>
            <a:r>
              <a:rPr lang="en-US" sz="1100" dirty="0"/>
              <a:t> or </a:t>
            </a:r>
            <a:r>
              <a:rPr lang="en-US" sz="1100" i="1" dirty="0"/>
              <a:t>COR47</a:t>
            </a:r>
            <a:r>
              <a:rPr lang="en-US" sz="1100" dirty="0"/>
              <a:t>. Names in parentheses on the x-axis indicate the lines from which the overexpressed alleles are cloned.  Error bars indicate SE for three biological replicates.  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779620" y="2198269"/>
            <a:ext cx="487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1 cm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1001935" y="381000"/>
            <a:ext cx="4713065" cy="2495361"/>
            <a:chOff x="1001935" y="381000"/>
            <a:chExt cx="4713065" cy="2495361"/>
          </a:xfrm>
        </p:grpSpPr>
        <p:grpSp>
          <p:nvGrpSpPr>
            <p:cNvPr id="11" name="Group 10"/>
            <p:cNvGrpSpPr/>
            <p:nvPr/>
          </p:nvGrpSpPr>
          <p:grpSpPr>
            <a:xfrm>
              <a:off x="1001935" y="381000"/>
              <a:ext cx="4713065" cy="2495361"/>
              <a:chOff x="522064" y="609600"/>
              <a:chExt cx="5029200" cy="2662741"/>
            </a:xfrm>
          </p:grpSpPr>
          <p:pic>
            <p:nvPicPr>
              <p:cNvPr id="2" name="Picture 5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2064" y="609600"/>
                <a:ext cx="5029200" cy="26627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3" name="Straight Connector 2"/>
              <p:cNvCxnSpPr/>
              <p:nvPr/>
            </p:nvCxnSpPr>
            <p:spPr>
              <a:xfrm>
                <a:off x="1001935" y="914400"/>
                <a:ext cx="119652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" name="Straight Connector 3"/>
              <p:cNvCxnSpPr/>
              <p:nvPr/>
            </p:nvCxnSpPr>
            <p:spPr>
              <a:xfrm>
                <a:off x="3722464" y="914400"/>
                <a:ext cx="119652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4"/>
              <p:cNvCxnSpPr/>
              <p:nvPr/>
            </p:nvCxnSpPr>
            <p:spPr>
              <a:xfrm>
                <a:off x="1131664" y="2275557"/>
                <a:ext cx="119652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903064" y="678510"/>
                <a:ext cx="1291858" cy="2955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bf2ox (sw:</a:t>
                </a:r>
                <a:r>
                  <a:rPr lang="en-US" sz="1200" i="1" dirty="0">
                    <a:solidFill>
                      <a:schemeClr val="bg1"/>
                    </a:solidFill>
                  </a:rPr>
                  <a:t>cbf2</a:t>
                </a:r>
                <a:r>
                  <a:rPr lang="en-US" sz="1200" dirty="0">
                    <a:solidFill>
                      <a:schemeClr val="bg1"/>
                    </a:solidFill>
                  </a:rPr>
                  <a:t>)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646264" y="668982"/>
                <a:ext cx="1450937" cy="2955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bf2ox of sw:cbf23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640858" y="2066596"/>
                <a:ext cx="5013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Ws-2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160458" y="2021557"/>
                <a:ext cx="1044448" cy="2955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</a:rPr>
                  <a:t>CBF2ox (SW)</a:t>
                </a:r>
              </a:p>
            </p:txBody>
          </p:sp>
        </p:grpSp>
        <p:sp>
          <p:nvSpPr>
            <p:cNvPr id="6" name="Rectangle 5"/>
            <p:cNvSpPr/>
            <p:nvPr/>
          </p:nvSpPr>
          <p:spPr>
            <a:xfrm>
              <a:off x="3501491" y="381000"/>
              <a:ext cx="2213509" cy="12476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1" name="TextBox 70"/>
          <p:cNvSpPr txBox="1"/>
          <p:nvPr/>
        </p:nvSpPr>
        <p:spPr>
          <a:xfrm>
            <a:off x="4785932" y="2177167"/>
            <a:ext cx="487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1 cm</a:t>
            </a:r>
          </a:p>
        </p:txBody>
      </p:sp>
      <p:graphicFrame>
        <p:nvGraphicFramePr>
          <p:cNvPr id="72" name="Chart 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970501"/>
              </p:ext>
            </p:extLst>
          </p:nvPr>
        </p:nvGraphicFramePr>
        <p:xfrm>
          <a:off x="950298" y="3279140"/>
          <a:ext cx="2239503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3" name="Chart 7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7571123"/>
              </p:ext>
            </p:extLst>
          </p:nvPr>
        </p:nvGraphicFramePr>
        <p:xfrm>
          <a:off x="838200" y="4673768"/>
          <a:ext cx="2239503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4" name="Chart 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3658028"/>
              </p:ext>
            </p:extLst>
          </p:nvPr>
        </p:nvGraphicFramePr>
        <p:xfrm>
          <a:off x="960897" y="5943600"/>
          <a:ext cx="2239503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5" name="Chart 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0593747"/>
              </p:ext>
            </p:extLst>
          </p:nvPr>
        </p:nvGraphicFramePr>
        <p:xfrm>
          <a:off x="3517900" y="3291840"/>
          <a:ext cx="2239503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6" name="Chart 7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37186946"/>
              </p:ext>
            </p:extLst>
          </p:nvPr>
        </p:nvGraphicFramePr>
        <p:xfrm>
          <a:off x="3562436" y="4661068"/>
          <a:ext cx="2239503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7" name="Chart 7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7571731"/>
              </p:ext>
            </p:extLst>
          </p:nvPr>
        </p:nvGraphicFramePr>
        <p:xfrm>
          <a:off x="3627897" y="5954468"/>
          <a:ext cx="2239503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pSp>
        <p:nvGrpSpPr>
          <p:cNvPr id="78" name="Group 77"/>
          <p:cNvGrpSpPr/>
          <p:nvPr/>
        </p:nvGrpSpPr>
        <p:grpSpPr>
          <a:xfrm>
            <a:off x="4398499" y="4541035"/>
            <a:ext cx="1262499" cy="0"/>
            <a:chOff x="1709778" y="4216400"/>
            <a:chExt cx="1262499" cy="0"/>
          </a:xfrm>
        </p:grpSpPr>
        <p:cxnSp>
          <p:nvCxnSpPr>
            <p:cNvPr id="79" name="Straight Connector 78"/>
            <p:cNvCxnSpPr/>
            <p:nvPr/>
          </p:nvCxnSpPr>
          <p:spPr>
            <a:xfrm>
              <a:off x="1709778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2438474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1" name="Group 80"/>
          <p:cNvGrpSpPr/>
          <p:nvPr/>
        </p:nvGrpSpPr>
        <p:grpSpPr>
          <a:xfrm>
            <a:off x="4398499" y="5943600"/>
            <a:ext cx="1262499" cy="0"/>
            <a:chOff x="1709778" y="4216400"/>
            <a:chExt cx="1262499" cy="0"/>
          </a:xfrm>
        </p:grpSpPr>
        <p:cxnSp>
          <p:nvCxnSpPr>
            <p:cNvPr id="82" name="Straight Connector 81"/>
            <p:cNvCxnSpPr/>
            <p:nvPr/>
          </p:nvCxnSpPr>
          <p:spPr>
            <a:xfrm>
              <a:off x="1709778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2438474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4" name="Group 83"/>
          <p:cNvGrpSpPr/>
          <p:nvPr/>
        </p:nvGrpSpPr>
        <p:grpSpPr>
          <a:xfrm>
            <a:off x="1740839" y="5943600"/>
            <a:ext cx="1262499" cy="0"/>
            <a:chOff x="1709778" y="4216400"/>
            <a:chExt cx="1262499" cy="0"/>
          </a:xfrm>
        </p:grpSpPr>
        <p:cxnSp>
          <p:nvCxnSpPr>
            <p:cNvPr id="85" name="Straight Connector 84"/>
            <p:cNvCxnSpPr/>
            <p:nvPr/>
          </p:nvCxnSpPr>
          <p:spPr>
            <a:xfrm>
              <a:off x="1709778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2438474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" name="Group 86"/>
          <p:cNvGrpSpPr/>
          <p:nvPr/>
        </p:nvGrpSpPr>
        <p:grpSpPr>
          <a:xfrm>
            <a:off x="1715884" y="7239000"/>
            <a:ext cx="1262499" cy="0"/>
            <a:chOff x="1709778" y="4216400"/>
            <a:chExt cx="1262499" cy="0"/>
          </a:xfrm>
        </p:grpSpPr>
        <p:cxnSp>
          <p:nvCxnSpPr>
            <p:cNvPr id="88" name="Straight Connector 87"/>
            <p:cNvCxnSpPr/>
            <p:nvPr/>
          </p:nvCxnSpPr>
          <p:spPr>
            <a:xfrm>
              <a:off x="1709778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2438474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" name="Group 89"/>
          <p:cNvGrpSpPr/>
          <p:nvPr/>
        </p:nvGrpSpPr>
        <p:grpSpPr>
          <a:xfrm>
            <a:off x="4439909" y="7239000"/>
            <a:ext cx="1262499" cy="0"/>
            <a:chOff x="1709778" y="4216400"/>
            <a:chExt cx="1262499" cy="0"/>
          </a:xfrm>
        </p:grpSpPr>
        <p:cxnSp>
          <p:nvCxnSpPr>
            <p:cNvPr id="91" name="Straight Connector 90"/>
            <p:cNvCxnSpPr/>
            <p:nvPr/>
          </p:nvCxnSpPr>
          <p:spPr>
            <a:xfrm>
              <a:off x="1709778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2438474" y="4216400"/>
              <a:ext cx="533803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385978" y="371113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328561" y="335280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912761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624</TotalTime>
  <Words>165</Words>
  <Application>Microsoft Macintosh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, Sunchung</dc:creator>
  <cp:lastModifiedBy>Thomashow, Michael</cp:lastModifiedBy>
  <cp:revision>228</cp:revision>
  <cp:lastPrinted>2017-03-13T20:53:07Z</cp:lastPrinted>
  <dcterms:created xsi:type="dcterms:W3CDTF">2006-08-16T00:00:00Z</dcterms:created>
  <dcterms:modified xsi:type="dcterms:W3CDTF">2018-11-09T14:25:55Z</dcterms:modified>
</cp:coreProperties>
</file>